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BC18C-B79B-4CDA-9FDE-656B1031A5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56EB0-D7A4-427B-8AFA-48D2DCA9E9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507FA-FE0F-46DC-B2B6-961B3E6672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D9D120-F77B-42DC-A010-CB193D5435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A84BF-E72C-4592-952B-2661C65475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FAAC15-D1C5-49C7-A6D8-5FED4933E8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9E7BF-C04B-4042-BEDE-2DEEDCBA51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E832D-768D-4976-B779-3E5FD11EE5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742C5-CABE-4E35-9F54-46E14EF7BE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0F750-B3C8-4246-AE01-8F70A31AD2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3A238-1B33-4B78-BAD2-1473DBCD0F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13EB7-B103-400F-8FA6-55ED0E21D4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1C2D63-574D-416A-9CB7-4BA9D3A0199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7627" t="0" r="7797" b="0"/>
          <a:stretch/>
        </p:blipFill>
        <p:spPr>
          <a:xfrm>
            <a:off x="5541840" y="488880"/>
            <a:ext cx="1127160" cy="13305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0" r="7627" b="0"/>
          <a:stretch/>
        </p:blipFill>
        <p:spPr>
          <a:xfrm>
            <a:off x="115920" y="490680"/>
            <a:ext cx="1230120" cy="13302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7627" t="0" r="7797" b="0"/>
          <a:stretch/>
        </p:blipFill>
        <p:spPr>
          <a:xfrm>
            <a:off x="1549440" y="488880"/>
            <a:ext cx="1127160" cy="133056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rcRect l="7797" t="0" r="7627" b="0"/>
          <a:stretch/>
        </p:blipFill>
        <p:spPr>
          <a:xfrm>
            <a:off x="2881440" y="488880"/>
            <a:ext cx="1125360" cy="133056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rcRect l="7797" t="0" r="7627" b="0"/>
          <a:stretch/>
        </p:blipFill>
        <p:spPr>
          <a:xfrm>
            <a:off x="4213080" y="488880"/>
            <a:ext cx="1125720" cy="133056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rcRect l="0" t="0" r="7627" b="0"/>
          <a:stretch/>
        </p:blipFill>
        <p:spPr>
          <a:xfrm>
            <a:off x="115920" y="1717560"/>
            <a:ext cx="1230120" cy="132876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7"/>
          <a:srcRect l="7627" t="0" r="7797" b="0"/>
          <a:stretch/>
        </p:blipFill>
        <p:spPr>
          <a:xfrm>
            <a:off x="1549440" y="1717560"/>
            <a:ext cx="1127160" cy="132876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8"/>
          <a:srcRect l="7797" t="0" r="7627" b="0"/>
          <a:stretch/>
        </p:blipFill>
        <p:spPr>
          <a:xfrm>
            <a:off x="2881440" y="1717560"/>
            <a:ext cx="1125360" cy="132876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9"/>
          <a:srcRect l="7797" t="0" r="7627" b="0"/>
          <a:stretch/>
        </p:blipFill>
        <p:spPr>
          <a:xfrm>
            <a:off x="4213080" y="1717560"/>
            <a:ext cx="1125720" cy="132876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10"/>
          <a:srcRect l="7627" t="0" r="7797" b="0"/>
          <a:stretch/>
        </p:blipFill>
        <p:spPr>
          <a:xfrm>
            <a:off x="5541840" y="1717560"/>
            <a:ext cx="1127160" cy="132876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11"/>
          <a:srcRect l="0" t="0" r="7627" b="0"/>
          <a:stretch/>
        </p:blipFill>
        <p:spPr>
          <a:xfrm>
            <a:off x="115920" y="2948040"/>
            <a:ext cx="1230120" cy="133020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12"/>
          <a:srcRect l="7627" t="0" r="7797" b="0"/>
          <a:stretch/>
        </p:blipFill>
        <p:spPr>
          <a:xfrm>
            <a:off x="1549440" y="2948040"/>
            <a:ext cx="1127160" cy="133020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13"/>
          <a:srcRect l="7797" t="0" r="7627" b="0"/>
          <a:stretch/>
        </p:blipFill>
        <p:spPr>
          <a:xfrm>
            <a:off x="2881440" y="2948040"/>
            <a:ext cx="1125360" cy="133020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14"/>
          <a:srcRect l="7797" t="0" r="7627" b="0"/>
          <a:stretch/>
        </p:blipFill>
        <p:spPr>
          <a:xfrm>
            <a:off x="4213080" y="2948040"/>
            <a:ext cx="1125720" cy="133020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15"/>
          <a:srcRect l="7627" t="0" r="7797" b="0"/>
          <a:stretch/>
        </p:blipFill>
        <p:spPr>
          <a:xfrm>
            <a:off x="5541840" y="2948040"/>
            <a:ext cx="1127160" cy="133020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16"/>
          <a:srcRect l="0" t="0" r="7627" b="0"/>
          <a:stretch/>
        </p:blipFill>
        <p:spPr>
          <a:xfrm>
            <a:off x="115920" y="4176720"/>
            <a:ext cx="1230120" cy="132876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17"/>
          <a:srcRect l="7627" t="0" r="7797" b="0"/>
          <a:stretch/>
        </p:blipFill>
        <p:spPr>
          <a:xfrm>
            <a:off x="1549440" y="4178160"/>
            <a:ext cx="1127160" cy="133056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18"/>
          <a:srcRect l="7797" t="0" r="7627" b="0"/>
          <a:stretch/>
        </p:blipFill>
        <p:spPr>
          <a:xfrm>
            <a:off x="2881440" y="4176720"/>
            <a:ext cx="1125360" cy="132876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19"/>
          <a:srcRect l="7797" t="0" r="7627" b="0"/>
          <a:stretch/>
        </p:blipFill>
        <p:spPr>
          <a:xfrm>
            <a:off x="4213080" y="4176720"/>
            <a:ext cx="1125720" cy="132876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0"/>
          <a:srcRect l="7627" t="0" r="7797" b="0"/>
          <a:stretch/>
        </p:blipFill>
        <p:spPr>
          <a:xfrm>
            <a:off x="5541840" y="4178160"/>
            <a:ext cx="1127160" cy="133056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21"/>
          <a:srcRect l="0" t="0" r="7627" b="0"/>
          <a:stretch/>
        </p:blipFill>
        <p:spPr>
          <a:xfrm>
            <a:off x="115920" y="5403960"/>
            <a:ext cx="1230120" cy="133020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22"/>
          <a:srcRect l="7627" t="0" r="7797" b="0"/>
          <a:stretch/>
        </p:blipFill>
        <p:spPr>
          <a:xfrm>
            <a:off x="1549440" y="5403960"/>
            <a:ext cx="1127160" cy="133020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3"/>
          <a:srcRect l="7797" t="0" r="7627" b="0"/>
          <a:stretch/>
        </p:blipFill>
        <p:spPr>
          <a:xfrm>
            <a:off x="2881440" y="5403960"/>
            <a:ext cx="1125360" cy="133020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24"/>
          <a:srcRect l="7797" t="0" r="7627" b="0"/>
          <a:stretch/>
        </p:blipFill>
        <p:spPr>
          <a:xfrm>
            <a:off x="4213080" y="5403960"/>
            <a:ext cx="1125720" cy="1330200"/>
          </a:xfrm>
          <a:prstGeom prst="rect">
            <a:avLst/>
          </a:prstGeom>
          <a:ln w="0">
            <a:noFill/>
          </a:ln>
        </p:spPr>
      </p:pic>
      <p:pic>
        <p:nvPicPr>
          <p:cNvPr id="65" name="" descr=""/>
          <p:cNvPicPr/>
          <p:nvPr/>
        </p:nvPicPr>
        <p:blipFill>
          <a:blip r:embed="rId25"/>
          <a:srcRect l="7627" t="0" r="7797" b="0"/>
          <a:stretch/>
        </p:blipFill>
        <p:spPr>
          <a:xfrm>
            <a:off x="5541840" y="5407200"/>
            <a:ext cx="1127160" cy="132840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26"/>
          <a:srcRect l="0" t="0" r="7627" b="7639"/>
          <a:stretch/>
        </p:blipFill>
        <p:spPr>
          <a:xfrm>
            <a:off x="115920" y="6634080"/>
            <a:ext cx="1230120" cy="122868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27"/>
          <a:srcRect l="7627" t="0" r="7797" b="7639"/>
          <a:stretch/>
        </p:blipFill>
        <p:spPr>
          <a:xfrm>
            <a:off x="1549440" y="6634080"/>
            <a:ext cx="1127160" cy="122868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28"/>
          <a:srcRect l="7797" t="0" r="7627" b="7639"/>
          <a:stretch/>
        </p:blipFill>
        <p:spPr>
          <a:xfrm>
            <a:off x="2881440" y="6634080"/>
            <a:ext cx="1125360" cy="122868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29"/>
          <a:srcRect l="7797" t="0" r="7627" b="7639"/>
          <a:stretch/>
        </p:blipFill>
        <p:spPr>
          <a:xfrm>
            <a:off x="4213080" y="6634080"/>
            <a:ext cx="1125720" cy="122868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30"/>
          <a:srcRect l="7627" t="0" r="7797" b="7639"/>
          <a:stretch/>
        </p:blipFill>
        <p:spPr>
          <a:xfrm>
            <a:off x="5541840" y="6634080"/>
            <a:ext cx="1127160" cy="122868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836640" y="48888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133360" y="48888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500280" y="48888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797360" y="48888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165720" y="48888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09640" y="171756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141640" y="171756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470040" y="171756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802040" y="171756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6134040" y="1717560"/>
            <a:ext cx="487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711000" y="294480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042640" y="294480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371400" y="294480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703400" y="294480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035400" y="294480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711000" y="417672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042640" y="417672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371400" y="417672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703400" y="417672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035400" y="417672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1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711000" y="540396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042640" y="540396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371400" y="540396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703400" y="540396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6035400" y="540396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711000" y="663264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042640" y="663264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371400" y="663264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703400" y="663264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035400" y="6632640"/>
            <a:ext cx="586800" cy="34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9960" rIns="129960" tIns="65160" bIns="65160" anchor="t">
            <a:spAutoFit/>
          </a:bodyPr>
          <a:p>
            <a:pPr algn="r">
              <a:tabLst>
                <a:tab algn="l" pos="0"/>
                <a:tab algn="l" pos="1300320"/>
                <a:tab algn="l" pos="2600280"/>
                <a:tab algn="l" pos="3900600"/>
                <a:tab algn="l" pos="5200560"/>
                <a:tab algn="l" pos="6500880"/>
                <a:tab algn="l" pos="7800840"/>
                <a:tab algn="l" pos="9101160"/>
                <a:tab algn="l" pos="104014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K2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60280" y="8337600"/>
            <a:ext cx="6337440" cy="6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300" spc="-1" strike="noStrike">
                <a:solidFill>
                  <a:srgbClr val="000000"/>
                </a:solidFill>
                <a:latin typeface="Times New Roman"/>
              </a:rPr>
              <a:t>Supplementary Data 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Normalised gene expression levels (y-axis) plotted across all 19 TobEA tissue types (x-axis) for set of 30 k-means clusters. Cluster identifiers shown in top right corner of each plo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20T14:33:09Z</dcterms:created>
  <dc:creator>edwardki</dc:creator>
  <dc:description/>
  <dc:language>en-US</dc:language>
  <cp:lastModifiedBy>edwardki</cp:lastModifiedBy>
  <dcterms:modified xsi:type="dcterms:W3CDTF">2009-09-28T10:55:54Z</dcterms:modified>
  <cp:revision>3</cp:revision>
  <dc:subject/>
  <dc:title>Slide 1</dc:title>
</cp:coreProperties>
</file>